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9" r:id="rId2"/>
    <p:sldId id="3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8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AD0577-3BBD-59C2-D9E8-ECA15C5B59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2CBED2-72CD-0F77-22C5-DCD979E570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E25ED-261D-328A-9EAC-450676D4F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907EC-63B4-DD31-D21B-F61E3FFB5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FFA321-1E55-9B7C-A86F-9F66A86E3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328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2B7EF-5BF3-C282-29A9-0BF6DFC75F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C404A2-3D4E-C2D7-7E31-F0F26C7538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818445-4377-273D-1590-D0C07CF56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B2D906-DECE-A8FD-201D-D6889D1E7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A1A2F-2262-9140-1ED1-B82A7BE6C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894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A01D4D-C04A-7B41-735B-015D59B814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358F45-4535-CC9F-2293-46A18A826F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F5F61A-3CA8-806E-AA89-7B3DDB7E3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0DB41-60F4-6891-BCDD-14E317339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C649B-0698-CC1E-3988-7E579C8DB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043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E9A6F3-1188-E256-A849-244677FAC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DD2054-3965-B3B1-605B-D8F82CA723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74BDE-A10B-615A-BACC-32A548E5A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390CAD-89E0-86AF-35CE-D406E0C6D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4C568C-938B-6FA8-A82B-45E274A88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427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3E11D-3BD5-D0A9-ADD7-0E1E4BE11C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506576-0579-2EB3-7649-3E0EB06E84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54191-9E55-1279-20F6-13FF4C648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F3E469-7CAD-EA00-6252-638ECC7A6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D92533-94B4-52E2-2D4A-DB63CED36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34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F212C-FFA3-9061-9C15-11907209B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ED0DBF-6AD2-03C8-A84B-E06AD9F03B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0BA2F4-35A1-42E9-118D-DAFD940E98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0FC39F-C28E-5D43-CFD0-C8A7BEA49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9DEEC9-AD4D-81D5-F9C4-CFEF9DE0E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870F65-E145-AD59-6465-1B5327942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592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49972-C0D3-AF11-E421-77D575B9D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F805C5-886A-B30C-C1DB-374C1FE55C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95B131-0C05-B4EA-682B-205CE3D0FA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7951E0-582B-AD1B-8B66-56969AF171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986C90-AA5E-C5F9-F793-6E5F9AE4C2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E41099-7233-3346-1271-BD98E5AFA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66A6226-127F-A550-F255-B9780B1A2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BA5FEE-E9AB-DAEF-B2EB-0DB7C4C5A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553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D6EC52-EBCF-FEC7-EA46-96E218681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EE9E97-F3C8-102B-50BE-7DCA7B584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501044-C966-E021-33D4-AB08EAFBB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451D30-EE87-1702-E3B2-A114C5697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17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8C5B5F-086D-8BF4-688D-D891C2D60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DC27D0-EFF8-CE23-C44C-C24C15118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A1627B-74C9-71D5-ECC0-2DC8673DA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679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A8D6F-2E6F-E09E-9E48-344F41B26E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0C37C3-D233-E210-728A-00CF3378FF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492D5F-324D-FF8B-787C-69D326F1F1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3F0A09-FCD2-7874-54ED-937ECA273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B0941A-EFD3-7245-0FD0-61B4F401B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8E163-61E8-48F4-40D8-FBDBF7955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038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23DBA-3625-E7E8-5ECA-B2D8E813D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13873C-4F4C-F39A-49A6-4A49946A7D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D815B1-DFED-FB47-A811-6D37F051D8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69DBC1-ADA7-A80F-5B60-B48F326BA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B4F38-335C-1864-178A-3641A198B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5E628-30B4-5A83-E35F-D4EABC3FE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023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C6C466-92E2-63AD-31A9-E3DB37BBC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82871A-81BF-51DD-04B0-27990D5B2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5DCE44-0D52-AC41-9527-74979FDB74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171A3-5E4F-4974-988D-65448F6A0204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7EE53-366C-B44B-A31A-B425F548BD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9B6106-5294-8410-A396-265CC033FD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3F9F0-3C0F-48DA-97FC-957D1DC2C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471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8DAD9360-4ADA-79C4-7A6A-5B504A6F44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b="14417"/>
          <a:stretch/>
        </p:blipFill>
        <p:spPr>
          <a:xfrm>
            <a:off x="3444240" y="1672"/>
            <a:ext cx="6385560" cy="1643077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36E03E59-1E0D-4DD2-11BA-32FDA6B72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75419" y="2299429"/>
            <a:ext cx="2541601" cy="631848"/>
          </a:xfrm>
        </p:spPr>
        <p:txBody>
          <a:bodyPr>
            <a:normAutofit fontScale="90000"/>
          </a:bodyPr>
          <a:lstStyle/>
          <a:p>
            <a:r>
              <a:rPr lang="en-US" sz="2700" dirty="0"/>
              <a:t>Supplemental Figure 2a</a:t>
            </a:r>
            <a:br>
              <a:rPr lang="en-US" sz="2700" dirty="0"/>
            </a:br>
            <a:r>
              <a:rPr lang="en-US" sz="2700" dirty="0"/>
              <a:t>Representative GC-MS data to generate figure 2</a:t>
            </a:r>
            <a:br>
              <a:rPr lang="en-US" dirty="0"/>
            </a:br>
            <a:br>
              <a:rPr lang="en-US" dirty="0"/>
            </a:b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CC12536-9FC0-E65E-8644-C2EBA06B9D0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4417"/>
          <a:stretch/>
        </p:blipFill>
        <p:spPr>
          <a:xfrm>
            <a:off x="3444240" y="1641887"/>
            <a:ext cx="6431280" cy="16548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1D817AD-9A93-94EE-5982-5310B94F14E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4417"/>
          <a:stretch/>
        </p:blipFill>
        <p:spPr>
          <a:xfrm>
            <a:off x="3444240" y="3296729"/>
            <a:ext cx="6385560" cy="164307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0DC5D69-75D6-B3E3-D25E-413DF59694E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4240" y="4978609"/>
            <a:ext cx="6431280" cy="1933618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E3554F5-750F-2664-600F-ED89AA8E9AB2}"/>
              </a:ext>
            </a:extLst>
          </p:cNvPr>
          <p:cNvCxnSpPr>
            <a:cxnSpLocks/>
          </p:cNvCxnSpPr>
          <p:nvPr/>
        </p:nvCxnSpPr>
        <p:spPr>
          <a:xfrm>
            <a:off x="4366549" y="509286"/>
            <a:ext cx="9892" cy="6080357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F8AA0BA3-EA26-CD9D-58A0-06D137E3390C}"/>
              </a:ext>
            </a:extLst>
          </p:cNvPr>
          <p:cNvSpPr txBox="1"/>
          <p:nvPr/>
        </p:nvSpPr>
        <p:spPr>
          <a:xfrm>
            <a:off x="4180102" y="295473"/>
            <a:ext cx="417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TS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0826C20-AD4E-7589-56CA-A148C2FC3B11}"/>
              </a:ext>
            </a:extLst>
          </p:cNvPr>
          <p:cNvSpPr txBox="1"/>
          <p:nvPr/>
        </p:nvSpPr>
        <p:spPr>
          <a:xfrm>
            <a:off x="2581628" y="651198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-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1BD616E-7D54-EC80-B4E9-CFC8A53A8C0D}"/>
              </a:ext>
            </a:extLst>
          </p:cNvPr>
          <p:cNvSpPr txBox="1"/>
          <p:nvPr/>
        </p:nvSpPr>
        <p:spPr>
          <a:xfrm>
            <a:off x="2588441" y="2330469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8-1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8E0D170-625E-8FDD-F9B1-21A547F108E8}"/>
              </a:ext>
            </a:extLst>
          </p:cNvPr>
          <p:cNvSpPr txBox="1"/>
          <p:nvPr/>
        </p:nvSpPr>
        <p:spPr>
          <a:xfrm>
            <a:off x="2578281" y="3779416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6-2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A8594D8-ED89-31FC-5559-75B08A321375}"/>
              </a:ext>
            </a:extLst>
          </p:cNvPr>
          <p:cNvSpPr txBox="1"/>
          <p:nvPr/>
        </p:nvSpPr>
        <p:spPr>
          <a:xfrm>
            <a:off x="2578882" y="5504934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24+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0947FDD-58D6-2358-C1C0-852ECF362AC3}"/>
              </a:ext>
            </a:extLst>
          </p:cNvPr>
          <p:cNvCxnSpPr>
            <a:cxnSpLocks/>
          </p:cNvCxnSpPr>
          <p:nvPr/>
        </p:nvCxnSpPr>
        <p:spPr>
          <a:xfrm>
            <a:off x="5075933" y="225698"/>
            <a:ext cx="16758" cy="6363945"/>
          </a:xfrm>
          <a:prstGeom prst="line">
            <a:avLst/>
          </a:prstGeom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6248915-6074-8C72-0D7A-27712C69CD74}"/>
              </a:ext>
            </a:extLst>
          </p:cNvPr>
          <p:cNvCxnSpPr>
            <a:cxnSpLocks/>
          </p:cNvCxnSpPr>
          <p:nvPr/>
        </p:nvCxnSpPr>
        <p:spPr>
          <a:xfrm>
            <a:off x="5310523" y="225698"/>
            <a:ext cx="0" cy="6363945"/>
          </a:xfrm>
          <a:prstGeom prst="line">
            <a:avLst/>
          </a:prstGeom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8B58BE2A-A0EF-D35C-27C6-C6AA51F47B37}"/>
              </a:ext>
            </a:extLst>
          </p:cNvPr>
          <p:cNvSpPr txBox="1"/>
          <p:nvPr/>
        </p:nvSpPr>
        <p:spPr>
          <a:xfrm>
            <a:off x="4636588" y="-89346"/>
            <a:ext cx="824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accent1"/>
                </a:solidFill>
              </a:rPr>
              <a:t>Octacosanol</a:t>
            </a:r>
            <a:endParaRPr lang="en-US" sz="1000" dirty="0">
              <a:solidFill>
                <a:schemeClr val="accent1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9B5449E-8967-E417-FB89-88498CD59B8B}"/>
              </a:ext>
            </a:extLst>
          </p:cNvPr>
          <p:cNvSpPr txBox="1"/>
          <p:nvPr/>
        </p:nvSpPr>
        <p:spPr>
          <a:xfrm>
            <a:off x="4968047" y="10665"/>
            <a:ext cx="7713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accent1"/>
                </a:solidFill>
              </a:rPr>
              <a:t>Triacotanol</a:t>
            </a:r>
            <a:endParaRPr lang="en-US" sz="1000" dirty="0">
              <a:solidFill>
                <a:schemeClr val="accent1"/>
              </a:solidFill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CA93DAE-2551-A032-41F8-98D5177DDC4F}"/>
              </a:ext>
            </a:extLst>
          </p:cNvPr>
          <p:cNvCxnSpPr>
            <a:cxnSpLocks/>
          </p:cNvCxnSpPr>
          <p:nvPr/>
        </p:nvCxnSpPr>
        <p:spPr>
          <a:xfrm>
            <a:off x="4999039" y="897896"/>
            <a:ext cx="28860" cy="5691747"/>
          </a:xfrm>
          <a:prstGeom prst="line">
            <a:avLst/>
          </a:prstGeom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18B068EF-07BB-2FC3-6A45-682E31778FD9}"/>
              </a:ext>
            </a:extLst>
          </p:cNvPr>
          <p:cNvSpPr txBox="1"/>
          <p:nvPr/>
        </p:nvSpPr>
        <p:spPr>
          <a:xfrm rot="16200000">
            <a:off x="4570345" y="461293"/>
            <a:ext cx="817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accent2"/>
                </a:solidFill>
              </a:rPr>
              <a:t>Octacosanal</a:t>
            </a:r>
            <a:endParaRPr lang="en-US" sz="1000" dirty="0">
              <a:solidFill>
                <a:schemeClr val="accent2"/>
              </a:solidFill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38C11E9-8F41-3F10-ADF3-D31C6F59843C}"/>
              </a:ext>
            </a:extLst>
          </p:cNvPr>
          <p:cNvCxnSpPr>
            <a:cxnSpLocks/>
          </p:cNvCxnSpPr>
          <p:nvPr/>
        </p:nvCxnSpPr>
        <p:spPr>
          <a:xfrm>
            <a:off x="5229845" y="897896"/>
            <a:ext cx="26171" cy="5691747"/>
          </a:xfrm>
          <a:prstGeom prst="line">
            <a:avLst/>
          </a:prstGeom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FA3C056F-7CBD-1B46-E3C8-CF53070F8B31}"/>
              </a:ext>
            </a:extLst>
          </p:cNvPr>
          <p:cNvSpPr txBox="1"/>
          <p:nvPr/>
        </p:nvSpPr>
        <p:spPr>
          <a:xfrm rot="16200000">
            <a:off x="4816567" y="485064"/>
            <a:ext cx="7649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accent2"/>
                </a:solidFill>
              </a:rPr>
              <a:t>Triacotanal</a:t>
            </a:r>
            <a:endParaRPr lang="en-US" sz="1000" dirty="0">
              <a:solidFill>
                <a:schemeClr val="accent2"/>
              </a:solidFill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49755B1-1DA8-31F3-9A49-AD2C2606F691}"/>
              </a:ext>
            </a:extLst>
          </p:cNvPr>
          <p:cNvCxnSpPr>
            <a:cxnSpLocks/>
          </p:cNvCxnSpPr>
          <p:nvPr/>
        </p:nvCxnSpPr>
        <p:spPr>
          <a:xfrm>
            <a:off x="5453075" y="897896"/>
            <a:ext cx="15556" cy="5691747"/>
          </a:xfrm>
          <a:prstGeom prst="line">
            <a:avLst/>
          </a:prstGeom>
          <a:ln w="9525" cap="flat" cmpd="sng" algn="ctr">
            <a:solidFill>
              <a:schemeClr val="accent2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F0EFA348-0F60-8556-F5BA-69B13AA69E02}"/>
              </a:ext>
            </a:extLst>
          </p:cNvPr>
          <p:cNvSpPr txBox="1"/>
          <p:nvPr/>
        </p:nvSpPr>
        <p:spPr>
          <a:xfrm rot="16200000">
            <a:off x="5004596" y="418584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chemeClr val="accent2"/>
                </a:solidFill>
              </a:rPr>
              <a:t>Dotriacotanal</a:t>
            </a:r>
            <a:endParaRPr lang="en-US" sz="10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39882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Oval 36">
            <a:extLst>
              <a:ext uri="{FF2B5EF4-FFF2-40B4-BE49-F238E27FC236}">
                <a16:creationId xmlns:a16="http://schemas.microsoft.com/office/drawing/2014/main" id="{10F27206-929E-D062-4EF6-00F0D09FBB4B}"/>
              </a:ext>
            </a:extLst>
          </p:cNvPr>
          <p:cNvSpPr/>
          <p:nvPr/>
        </p:nvSpPr>
        <p:spPr>
          <a:xfrm>
            <a:off x="4891548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EGL3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49793A7-77A6-E089-8646-B7E1380528AE}"/>
              </a:ext>
            </a:extLst>
          </p:cNvPr>
          <p:cNvSpPr/>
          <p:nvPr/>
        </p:nvSpPr>
        <p:spPr>
          <a:xfrm>
            <a:off x="8137176" y="9988637"/>
            <a:ext cx="1322773" cy="706283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42900"/>
            <a:r>
              <a:rPr lang="en-US" dirty="0">
                <a:solidFill>
                  <a:prstClr val="white"/>
                </a:solidFill>
                <a:latin typeface="Calibri" panose="020F0502020204030204"/>
              </a:rPr>
              <a:t>FM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6C5CFC7-847B-8FC3-1C1B-E32947EF09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3735" y="5259796"/>
            <a:ext cx="5233628" cy="157353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741613C-C74E-0477-AA38-A3B96E528AD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3351"/>
          <a:stretch/>
        </p:blipFill>
        <p:spPr>
          <a:xfrm>
            <a:off x="4123735" y="4113729"/>
            <a:ext cx="5233629" cy="136343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22C7FD9-2E81-A772-E8FA-43C7480E034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4569"/>
          <a:stretch/>
        </p:blipFill>
        <p:spPr>
          <a:xfrm>
            <a:off x="4123735" y="2970317"/>
            <a:ext cx="5233628" cy="134426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7D1B576-D5E2-D57C-F50A-937A2B86397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3222"/>
          <a:stretch/>
        </p:blipFill>
        <p:spPr>
          <a:xfrm>
            <a:off x="4123734" y="1807740"/>
            <a:ext cx="5233630" cy="136549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E99AEDE-C725-2434-3BEB-A7531734055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" b="14569"/>
          <a:stretch/>
        </p:blipFill>
        <p:spPr>
          <a:xfrm>
            <a:off x="4123733" y="636961"/>
            <a:ext cx="5233628" cy="134426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4316103-B9BB-8F8D-F336-7E76449315C1}"/>
              </a:ext>
            </a:extLst>
          </p:cNvPr>
          <p:cNvSpPr txBox="1"/>
          <p:nvPr/>
        </p:nvSpPr>
        <p:spPr>
          <a:xfrm>
            <a:off x="3124180" y="2304790"/>
            <a:ext cx="607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-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1FFAF06-627D-B401-3367-54DE41596572}"/>
              </a:ext>
            </a:extLst>
          </p:cNvPr>
          <p:cNvSpPr txBox="1"/>
          <p:nvPr/>
        </p:nvSpPr>
        <p:spPr>
          <a:xfrm>
            <a:off x="3124180" y="3457785"/>
            <a:ext cx="724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8-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FE1A59-78C0-88D4-D897-1233E52C7840}"/>
              </a:ext>
            </a:extLst>
          </p:cNvPr>
          <p:cNvSpPr txBox="1"/>
          <p:nvPr/>
        </p:nvSpPr>
        <p:spPr>
          <a:xfrm>
            <a:off x="3124180" y="4629682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16-2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B8A405D-E345-5879-7294-28D0AAC2F59C}"/>
              </a:ext>
            </a:extLst>
          </p:cNvPr>
          <p:cNvSpPr txBox="1"/>
          <p:nvPr/>
        </p:nvSpPr>
        <p:spPr>
          <a:xfrm>
            <a:off x="3124180" y="5801579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24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92A3B5-490A-46BF-1C8D-3CA92330EE03}"/>
              </a:ext>
            </a:extLst>
          </p:cNvPr>
          <p:cNvSpPr txBox="1"/>
          <p:nvPr/>
        </p:nvSpPr>
        <p:spPr>
          <a:xfrm>
            <a:off x="2630198" y="1124429"/>
            <a:ext cx="1543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rnauba Wax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3C354FB-5860-5842-C3C4-241DD4F3F655}"/>
              </a:ext>
            </a:extLst>
          </p:cNvPr>
          <p:cNvSpPr txBox="1"/>
          <p:nvPr/>
        </p:nvSpPr>
        <p:spPr>
          <a:xfrm>
            <a:off x="328138" y="225424"/>
            <a:ext cx="60976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Figure 2b</a:t>
            </a:r>
            <a:br>
              <a:rPr lang="en-US" dirty="0"/>
            </a:br>
            <a:r>
              <a:rPr lang="en-US" dirty="0"/>
              <a:t>Representative GC-MS data to generate figure 2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4201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Widescreen</PresentationFormat>
  <Paragraphs>1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l Figure 2a Representative GC-MS data to generate figure 2 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: Sorghum Stem Development and SEM tissue collection</dc:title>
  <dc:creator>Robert Chemelewski</dc:creator>
  <cp:lastModifiedBy>Abby Rassette</cp:lastModifiedBy>
  <cp:revision>2</cp:revision>
  <dcterms:created xsi:type="dcterms:W3CDTF">2023-05-23T18:32:28Z</dcterms:created>
  <dcterms:modified xsi:type="dcterms:W3CDTF">2023-09-11T14:31:10Z</dcterms:modified>
</cp:coreProperties>
</file>